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7" r:id="rId2"/>
    <p:sldId id="347" r:id="rId3"/>
    <p:sldId id="348" r:id="rId4"/>
    <p:sldId id="349" r:id="rId5"/>
    <p:sldId id="350" r:id="rId6"/>
  </p:sldIdLst>
  <p:sldSz cx="77724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341" autoAdjust="0"/>
    <p:restoredTop sz="92272" autoAdjust="0"/>
  </p:normalViewPr>
  <p:slideViewPr>
    <p:cSldViewPr snapToGrid="0">
      <p:cViewPr varScale="1">
        <p:scale>
          <a:sx n="67" d="100"/>
          <a:sy n="67" d="100"/>
        </p:scale>
        <p:origin x="304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image" Target="../media/image18.emf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12" Type="http://schemas.openxmlformats.org/officeDocument/2006/relationships/image" Target="../media/image17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6" Type="http://schemas.openxmlformats.org/officeDocument/2006/relationships/image" Target="../media/image11.emf"/><Relationship Id="rId11" Type="http://schemas.openxmlformats.org/officeDocument/2006/relationships/image" Target="../media/image16.emf"/><Relationship Id="rId5" Type="http://schemas.openxmlformats.org/officeDocument/2006/relationships/image" Target="../media/image10.emf"/><Relationship Id="rId10" Type="http://schemas.openxmlformats.org/officeDocument/2006/relationships/image" Target="../media/image15.emf"/><Relationship Id="rId4" Type="http://schemas.openxmlformats.org/officeDocument/2006/relationships/image" Target="../media/image9.emf"/><Relationship Id="rId9" Type="http://schemas.openxmlformats.org/officeDocument/2006/relationships/image" Target="../media/image14.emf"/><Relationship Id="rId14" Type="http://schemas.openxmlformats.org/officeDocument/2006/relationships/image" Target="../media/image1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CE1B205-3084-49D3-99AA-FF4B73C2853F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25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CCD487B-1B21-4B74-8FFA-2EAD1A16AB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957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539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503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101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499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464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632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972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5880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480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193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669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4F175-00C7-4760-B207-957A6170E2E2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6CE035-4979-4F77-935B-A3DD18AA3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711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3.emf"/><Relationship Id="rId26" Type="http://schemas.openxmlformats.org/officeDocument/2006/relationships/image" Target="../media/image17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0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2.emf"/><Relationship Id="rId20" Type="http://schemas.openxmlformats.org/officeDocument/2006/relationships/image" Target="../media/image14.emf"/><Relationship Id="rId29" Type="http://schemas.openxmlformats.org/officeDocument/2006/relationships/oleObject" Target="../embeddings/oleObject14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6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8.emf"/><Relationship Id="rId10" Type="http://schemas.openxmlformats.org/officeDocument/2006/relationships/image" Target="../media/image9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6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1.emf"/><Relationship Id="rId22" Type="http://schemas.openxmlformats.org/officeDocument/2006/relationships/image" Target="../media/image15.e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19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7D8471A8-CC7C-40B8-B1B0-CFEE830FEE62}"/>
              </a:ext>
            </a:extLst>
          </p:cNvPr>
          <p:cNvSpPr txBox="1"/>
          <p:nvPr/>
        </p:nvSpPr>
        <p:spPr>
          <a:xfrm>
            <a:off x="0" y="0"/>
            <a:ext cx="3357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XCL12 and CXCR4 expression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AEAB616-1F03-4552-8BA4-12AEC73963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8492" y="1472447"/>
            <a:ext cx="6881008" cy="2057412"/>
          </a:xfrm>
          <a:prstGeom prst="rect">
            <a:avLst/>
          </a:prstGeom>
        </p:spPr>
      </p:pic>
      <p:pic>
        <p:nvPicPr>
          <p:cNvPr id="13" name="Picture 12" descr="Chart&#10;&#10;Description automatically generated">
            <a:extLst>
              <a:ext uri="{FF2B5EF4-FFF2-40B4-BE49-F238E27FC236}">
                <a16:creationId xmlns:a16="http://schemas.microsoft.com/office/drawing/2014/main" id="{3CCA5FEF-AA08-48C5-A808-C9C51448042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793" y="3773844"/>
            <a:ext cx="5942454" cy="2711993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4308AEB-852A-429D-A8F0-DE6017399E08}"/>
              </a:ext>
            </a:extLst>
          </p:cNvPr>
          <p:cNvSpPr txBox="1"/>
          <p:nvPr/>
        </p:nvSpPr>
        <p:spPr>
          <a:xfrm>
            <a:off x="561113" y="3919206"/>
            <a:ext cx="215301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19C1972-FEDD-4DB5-8330-D3BB02CCEBFC}"/>
              </a:ext>
            </a:extLst>
          </p:cNvPr>
          <p:cNvSpPr txBox="1"/>
          <p:nvPr/>
        </p:nvSpPr>
        <p:spPr>
          <a:xfrm>
            <a:off x="668763" y="1558738"/>
            <a:ext cx="215301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022C09B-DD14-46C1-A945-0356124443AA}"/>
              </a:ext>
            </a:extLst>
          </p:cNvPr>
          <p:cNvSpPr txBox="1"/>
          <p:nvPr/>
        </p:nvSpPr>
        <p:spPr>
          <a:xfrm>
            <a:off x="2248636" y="1558738"/>
            <a:ext cx="215301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B42B9A6-3622-4AB8-8AD9-285007725F8C}"/>
              </a:ext>
            </a:extLst>
          </p:cNvPr>
          <p:cNvSpPr/>
          <p:nvPr/>
        </p:nvSpPr>
        <p:spPr>
          <a:xfrm>
            <a:off x="447261" y="3888428"/>
            <a:ext cx="618892" cy="3655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E99C834-8F8B-4FB8-8902-77AAC8D17EF9}"/>
              </a:ext>
            </a:extLst>
          </p:cNvPr>
          <p:cNvSpPr txBox="1"/>
          <p:nvPr/>
        </p:nvSpPr>
        <p:spPr>
          <a:xfrm>
            <a:off x="668762" y="3888428"/>
            <a:ext cx="215301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163A16-7986-8AA8-EF00-4EC4A811DFFF}"/>
              </a:ext>
            </a:extLst>
          </p:cNvPr>
          <p:cNvSpPr txBox="1"/>
          <p:nvPr/>
        </p:nvSpPr>
        <p:spPr>
          <a:xfrm>
            <a:off x="6832600" y="0"/>
            <a:ext cx="939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ufi et al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DE0153A-35D8-73B7-EC04-25BD10E3F56E}"/>
              </a:ext>
            </a:extLst>
          </p:cNvPr>
          <p:cNvSpPr txBox="1"/>
          <p:nvPr/>
        </p:nvSpPr>
        <p:spPr>
          <a:xfrm>
            <a:off x="2553436" y="3235138"/>
            <a:ext cx="717848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l-GR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19419379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>
            <a:extLst>
              <a:ext uri="{FF2B5EF4-FFF2-40B4-BE49-F238E27FC236}">
                <a16:creationId xmlns:a16="http://schemas.microsoft.com/office/drawing/2014/main" id="{A934DA1F-F7A1-42B5-977D-C9BB04325ADA}"/>
              </a:ext>
            </a:extLst>
          </p:cNvPr>
          <p:cNvSpPr txBox="1"/>
          <p:nvPr/>
        </p:nvSpPr>
        <p:spPr>
          <a:xfrm rot="16200000">
            <a:off x="348165" y="2577606"/>
            <a:ext cx="1781634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30" dirty="0"/>
              <a:t>PBMC (x 10</a:t>
            </a:r>
            <a:r>
              <a:rPr lang="en-US" sz="1530" baseline="30000" dirty="0"/>
              <a:t>3 </a:t>
            </a:r>
            <a:r>
              <a:rPr lang="en-US" sz="1530" dirty="0"/>
              <a:t>cells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1A580BA-78A1-4774-9BAF-1AF785540B4B}"/>
              </a:ext>
            </a:extLst>
          </p:cNvPr>
          <p:cNvSpPr txBox="1"/>
          <p:nvPr/>
        </p:nvSpPr>
        <p:spPr>
          <a:xfrm>
            <a:off x="1356711" y="2789336"/>
            <a:ext cx="423933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dirty="0"/>
              <a:t>2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FC39DA2-67D6-448B-B62F-B3E7BE027FA2}"/>
              </a:ext>
            </a:extLst>
          </p:cNvPr>
          <p:cNvSpPr txBox="1"/>
          <p:nvPr/>
        </p:nvSpPr>
        <p:spPr>
          <a:xfrm>
            <a:off x="1357853" y="2210149"/>
            <a:ext cx="423933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dirty="0"/>
              <a:t>4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5EFB3C6-FB57-491E-9487-310B813C0D46}"/>
              </a:ext>
            </a:extLst>
          </p:cNvPr>
          <p:cNvSpPr txBox="1"/>
          <p:nvPr/>
        </p:nvSpPr>
        <p:spPr>
          <a:xfrm>
            <a:off x="1358996" y="1614938"/>
            <a:ext cx="423933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dirty="0"/>
              <a:t>6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30CEBE2-C9E7-4419-9F64-DA516D6B8F69}"/>
              </a:ext>
            </a:extLst>
          </p:cNvPr>
          <p:cNvSpPr txBox="1"/>
          <p:nvPr/>
        </p:nvSpPr>
        <p:spPr>
          <a:xfrm>
            <a:off x="1697217" y="3730418"/>
            <a:ext cx="545269" cy="288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dirty="0"/>
              <a:t>TCM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54584A2-D4BA-4603-921E-55602B8AD806}"/>
              </a:ext>
            </a:extLst>
          </p:cNvPr>
          <p:cNvSpPr txBox="1"/>
          <p:nvPr/>
        </p:nvSpPr>
        <p:spPr>
          <a:xfrm>
            <a:off x="2231868" y="3730418"/>
            <a:ext cx="582413" cy="288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dirty="0"/>
              <a:t>OGM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52BA174-5ABD-43BB-A964-EE170D622C58}"/>
              </a:ext>
            </a:extLst>
          </p:cNvPr>
          <p:cNvSpPr txBox="1"/>
          <p:nvPr/>
        </p:nvSpPr>
        <p:spPr>
          <a:xfrm>
            <a:off x="2800819" y="3632314"/>
            <a:ext cx="599745" cy="484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dirty="0"/>
              <a:t>TCM/</a:t>
            </a:r>
          </a:p>
          <a:p>
            <a:pPr algn="ctr"/>
            <a:r>
              <a:rPr lang="en-US" sz="1275" dirty="0"/>
              <a:t>OGM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F34F606-C1B9-44C4-A2FB-C5F9AA69A902}"/>
              </a:ext>
            </a:extLst>
          </p:cNvPr>
          <p:cNvSpPr txBox="1"/>
          <p:nvPr/>
        </p:nvSpPr>
        <p:spPr>
          <a:xfrm>
            <a:off x="5332098" y="3719332"/>
            <a:ext cx="599746" cy="288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dirty="0"/>
              <a:t>PDAC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960F00F-5120-408D-9096-67D9ED987481}"/>
              </a:ext>
            </a:extLst>
          </p:cNvPr>
          <p:cNvSpPr txBox="1"/>
          <p:nvPr/>
        </p:nvSpPr>
        <p:spPr>
          <a:xfrm>
            <a:off x="5741603" y="3719332"/>
            <a:ext cx="922284" cy="288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dirty="0"/>
              <a:t>Adjacen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EF142AA-E7BE-49B8-80CC-90CFB1A53156}"/>
              </a:ext>
            </a:extLst>
          </p:cNvPr>
          <p:cNvSpPr txBox="1"/>
          <p:nvPr/>
        </p:nvSpPr>
        <p:spPr>
          <a:xfrm>
            <a:off x="2559175" y="1632606"/>
            <a:ext cx="1682778" cy="288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75" dirty="0"/>
              <a:t> Untreated PBMC 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CBD47ADE-DB9A-4811-B1FD-35B177CF0935}"/>
              </a:ext>
            </a:extLst>
          </p:cNvPr>
          <p:cNvSpPr/>
          <p:nvPr/>
        </p:nvSpPr>
        <p:spPr>
          <a:xfrm>
            <a:off x="2350020" y="1714687"/>
            <a:ext cx="209155" cy="9481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4208">
              <a:solidFill>
                <a:schemeClr val="tx1"/>
              </a:solidFill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347D2C78-09B1-4A51-BC91-59368010EE82}"/>
              </a:ext>
            </a:extLst>
          </p:cNvPr>
          <p:cNvSpPr/>
          <p:nvPr/>
        </p:nvSpPr>
        <p:spPr>
          <a:xfrm>
            <a:off x="2350020" y="1884589"/>
            <a:ext cx="209155" cy="94814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4208">
              <a:solidFill>
                <a:schemeClr val="tx1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7D07C70-8880-4825-8B8B-4064D29B6132}"/>
              </a:ext>
            </a:extLst>
          </p:cNvPr>
          <p:cNvSpPr txBox="1"/>
          <p:nvPr/>
        </p:nvSpPr>
        <p:spPr>
          <a:xfrm>
            <a:off x="2559175" y="1799439"/>
            <a:ext cx="1433301" cy="288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75" dirty="0"/>
              <a:t> CXCR4i-PBMC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5BA083E-536C-4154-B6CD-A3A2993595C8}"/>
              </a:ext>
            </a:extLst>
          </p:cNvPr>
          <p:cNvSpPr txBox="1"/>
          <p:nvPr/>
        </p:nvSpPr>
        <p:spPr>
          <a:xfrm>
            <a:off x="-10308" y="5774"/>
            <a:ext cx="6686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ffect of media and patient derived tumor organoid supernatant on PBMC migration.</a:t>
            </a: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4706CF96-4E74-4B0E-8735-7F63D83BC4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2299"/>
          <a:stretch/>
        </p:blipFill>
        <p:spPr>
          <a:xfrm>
            <a:off x="1513464" y="1573681"/>
            <a:ext cx="1887100" cy="2250948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C66059AA-B1EC-4771-83D8-ADED6426B30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91266"/>
          <a:stretch/>
        </p:blipFill>
        <p:spPr>
          <a:xfrm>
            <a:off x="4496139" y="1577363"/>
            <a:ext cx="285656" cy="2250948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7E8DEAAB-0DAA-41BC-B95B-4BF618DDB71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9135"/>
          <a:stretch/>
        </p:blipFill>
        <p:spPr>
          <a:xfrm>
            <a:off x="4746570" y="1577363"/>
            <a:ext cx="1990582" cy="2250948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8CC6F5F4-CA83-446A-8BC5-F5882170D28E}"/>
              </a:ext>
            </a:extLst>
          </p:cNvPr>
          <p:cNvSpPr txBox="1"/>
          <p:nvPr/>
        </p:nvSpPr>
        <p:spPr>
          <a:xfrm rot="16200000">
            <a:off x="3293501" y="2557016"/>
            <a:ext cx="1822813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30" dirty="0"/>
              <a:t>PBMC (x 10</a:t>
            </a:r>
            <a:r>
              <a:rPr lang="en-US" sz="1530" baseline="30000" dirty="0"/>
              <a:t>3 </a:t>
            </a:r>
            <a:r>
              <a:rPr lang="en-US" sz="1530" dirty="0"/>
              <a:t>cells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F29B5F0-3728-4192-B1FD-F9E390149514}"/>
              </a:ext>
            </a:extLst>
          </p:cNvPr>
          <p:cNvSpPr txBox="1"/>
          <p:nvPr/>
        </p:nvSpPr>
        <p:spPr>
          <a:xfrm>
            <a:off x="4322637" y="2896282"/>
            <a:ext cx="423933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dirty="0"/>
              <a:t>2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B91C8F1-980A-4490-B3E1-06B9D68E1C90}"/>
              </a:ext>
            </a:extLst>
          </p:cNvPr>
          <p:cNvSpPr txBox="1"/>
          <p:nvPr/>
        </p:nvSpPr>
        <p:spPr>
          <a:xfrm>
            <a:off x="4323779" y="2317095"/>
            <a:ext cx="423933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dirty="0"/>
              <a:t>4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CE663EE-FA4A-4B90-892E-75B5B1928C34}"/>
              </a:ext>
            </a:extLst>
          </p:cNvPr>
          <p:cNvSpPr txBox="1"/>
          <p:nvPr/>
        </p:nvSpPr>
        <p:spPr>
          <a:xfrm>
            <a:off x="4324922" y="1721884"/>
            <a:ext cx="423933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dirty="0"/>
              <a:t>6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8BD92BC-DF52-47D8-AD6E-114E7DEAE6C4}"/>
              </a:ext>
            </a:extLst>
          </p:cNvPr>
          <p:cNvSpPr txBox="1"/>
          <p:nvPr/>
        </p:nvSpPr>
        <p:spPr>
          <a:xfrm>
            <a:off x="4716190" y="3747056"/>
            <a:ext cx="599745" cy="484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dirty="0"/>
              <a:t>TCM/</a:t>
            </a:r>
          </a:p>
          <a:p>
            <a:pPr algn="ctr"/>
            <a:r>
              <a:rPr lang="en-US" sz="1275" dirty="0"/>
              <a:t>OGM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C7EC50D-A72B-4DEF-AF01-A186C27D02C8}"/>
              </a:ext>
            </a:extLst>
          </p:cNvPr>
          <p:cNvSpPr txBox="1"/>
          <p:nvPr/>
        </p:nvSpPr>
        <p:spPr>
          <a:xfrm>
            <a:off x="5507335" y="4007873"/>
            <a:ext cx="922284" cy="288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dirty="0"/>
              <a:t>PDOs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E4D85500-ACC0-4E10-A8A8-39B19E845D2F}"/>
              </a:ext>
            </a:extLst>
          </p:cNvPr>
          <p:cNvCxnSpPr>
            <a:cxnSpLocks/>
          </p:cNvCxnSpPr>
          <p:nvPr/>
        </p:nvCxnSpPr>
        <p:spPr>
          <a:xfrm>
            <a:off x="5434011" y="4007873"/>
            <a:ext cx="99560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571A233C-412B-45C2-A34C-02292469AB66}"/>
              </a:ext>
            </a:extLst>
          </p:cNvPr>
          <p:cNvSpPr txBox="1"/>
          <p:nvPr/>
        </p:nvSpPr>
        <p:spPr>
          <a:xfrm>
            <a:off x="1096392" y="1499877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301D706-3894-4867-BF40-B56C9D3D875B}"/>
              </a:ext>
            </a:extLst>
          </p:cNvPr>
          <p:cNvSpPr txBox="1"/>
          <p:nvPr/>
        </p:nvSpPr>
        <p:spPr>
          <a:xfrm>
            <a:off x="4050922" y="1573681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B5473C0-F709-85BA-5FC4-1B373280380D}"/>
              </a:ext>
            </a:extLst>
          </p:cNvPr>
          <p:cNvSpPr txBox="1"/>
          <p:nvPr/>
        </p:nvSpPr>
        <p:spPr>
          <a:xfrm>
            <a:off x="6832600" y="0"/>
            <a:ext cx="939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ufi et al.</a:t>
            </a:r>
          </a:p>
        </p:txBody>
      </p:sp>
    </p:spTree>
    <p:extLst>
      <p:ext uri="{BB962C8B-B14F-4D97-AF65-F5344CB8AC3E}">
        <p14:creationId xmlns:p14="http://schemas.microsoft.com/office/powerpoint/2010/main" val="17329248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D67F0B5-E8C1-403C-9DDA-416E6E8AE67A}"/>
              </a:ext>
            </a:extLst>
          </p:cNvPr>
          <p:cNvSpPr txBox="1"/>
          <p:nvPr/>
        </p:nvSpPr>
        <p:spPr>
          <a:xfrm>
            <a:off x="0" y="5579"/>
            <a:ext cx="43327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harmacodynamics of AMD300 and gemcitabine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2F3DA1B-6E8B-4477-AB99-DEB0AF7F947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741" t="36275" b="26470"/>
          <a:stretch/>
        </p:blipFill>
        <p:spPr>
          <a:xfrm>
            <a:off x="2272467" y="1565550"/>
            <a:ext cx="3227465" cy="2593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62F6F5B-1F5E-404A-92FE-AF763D7ECBB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0115"/>
          <a:stretch/>
        </p:blipFill>
        <p:spPr>
          <a:xfrm>
            <a:off x="2209790" y="4318470"/>
            <a:ext cx="3405611" cy="231751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2EDA645-136C-4F11-AE2B-702F2CD67CD5}"/>
              </a:ext>
            </a:extLst>
          </p:cNvPr>
          <p:cNvSpPr txBox="1"/>
          <p:nvPr/>
        </p:nvSpPr>
        <p:spPr>
          <a:xfrm>
            <a:off x="2107059" y="4270731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70CD9756-D850-4A00-81BB-2C7B50BEA33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51755"/>
          <a:stretch/>
        </p:blipFill>
        <p:spPr>
          <a:xfrm>
            <a:off x="2228527" y="6795501"/>
            <a:ext cx="3441702" cy="242167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FB96BDB-E54F-41AE-ABFE-63127D0C430C}"/>
              </a:ext>
            </a:extLst>
          </p:cNvPr>
          <p:cNvSpPr txBox="1"/>
          <p:nvPr/>
        </p:nvSpPr>
        <p:spPr>
          <a:xfrm>
            <a:off x="2107059" y="6700485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50EE4A-F0AD-4D82-9434-D4F8701099C0}"/>
              </a:ext>
            </a:extLst>
          </p:cNvPr>
          <p:cNvSpPr txBox="1"/>
          <p:nvPr/>
        </p:nvSpPr>
        <p:spPr>
          <a:xfrm>
            <a:off x="3801572" y="4301509"/>
            <a:ext cx="692094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 = 0.02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60B0D6A7-3D90-40E1-84A9-CF12DBA63F9C}"/>
              </a:ext>
            </a:extLst>
          </p:cNvPr>
          <p:cNvCxnSpPr>
            <a:cxnSpLocks/>
          </p:cNvCxnSpPr>
          <p:nvPr/>
        </p:nvCxnSpPr>
        <p:spPr>
          <a:xfrm>
            <a:off x="3483975" y="4511625"/>
            <a:ext cx="132728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19B499DF-403B-0216-70F4-BF2516E1D647}"/>
              </a:ext>
            </a:extLst>
          </p:cNvPr>
          <p:cNvSpPr txBox="1"/>
          <p:nvPr/>
        </p:nvSpPr>
        <p:spPr>
          <a:xfrm>
            <a:off x="2109559" y="1604982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811EF01-B0A4-6102-20C4-AAF56C70A736}"/>
              </a:ext>
            </a:extLst>
          </p:cNvPr>
          <p:cNvSpPr txBox="1"/>
          <p:nvPr/>
        </p:nvSpPr>
        <p:spPr>
          <a:xfrm>
            <a:off x="6832600" y="0"/>
            <a:ext cx="939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ufi et al.</a:t>
            </a:r>
          </a:p>
        </p:txBody>
      </p:sp>
    </p:spTree>
    <p:extLst>
      <p:ext uri="{BB962C8B-B14F-4D97-AF65-F5344CB8AC3E}">
        <p14:creationId xmlns:p14="http://schemas.microsoft.com/office/powerpoint/2010/main" val="31618968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78F6057-7E0B-498C-B0A4-DCAF289FE8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9850297"/>
              </p:ext>
            </p:extLst>
          </p:nvPr>
        </p:nvGraphicFramePr>
        <p:xfrm>
          <a:off x="2881050" y="3629476"/>
          <a:ext cx="830230" cy="12194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6" r:id="rId3" imgW="2085546" imgH="3064551" progId="Prism6.Document">
                  <p:embed/>
                </p:oleObj>
              </mc:Choice>
              <mc:Fallback>
                <p:oleObj name="Prism 6" r:id="rId3" imgW="2085546" imgH="3064551" progId="Prism6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81050" y="3629476"/>
                        <a:ext cx="830230" cy="12194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5A2A97C4-DA8F-4874-9E74-F8374D3A54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8741226"/>
              </p:ext>
            </p:extLst>
          </p:nvPr>
        </p:nvGraphicFramePr>
        <p:xfrm>
          <a:off x="2871526" y="1863881"/>
          <a:ext cx="815698" cy="11575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6" r:id="rId5" imgW="2049172" imgH="2908964" progId="Prism6.Document">
                  <p:embed/>
                </p:oleObj>
              </mc:Choice>
              <mc:Fallback>
                <p:oleObj name="Prism 6" r:id="rId5" imgW="2049172" imgH="2908964" progId="Prism6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71526" y="1863881"/>
                        <a:ext cx="815698" cy="11575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D19A16CB-F143-480E-BB7F-BFC969DE75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2373467"/>
              </p:ext>
            </p:extLst>
          </p:nvPr>
        </p:nvGraphicFramePr>
        <p:xfrm>
          <a:off x="2910688" y="5675593"/>
          <a:ext cx="837180" cy="11467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6" r:id="rId7" imgW="2103913" imgH="2881592" progId="Prism6.Document">
                  <p:embed/>
                </p:oleObj>
              </mc:Choice>
              <mc:Fallback>
                <p:oleObj name="Prism 6" r:id="rId7" imgW="2103913" imgH="2881592" progId="Prism6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910688" y="5675593"/>
                        <a:ext cx="837180" cy="11467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DBD5B193-9B3B-4A4F-8EEB-D28D16B8F3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6860987"/>
              </p:ext>
            </p:extLst>
          </p:nvPr>
        </p:nvGraphicFramePr>
        <p:xfrm>
          <a:off x="6527828" y="1834014"/>
          <a:ext cx="834021" cy="12162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6" r:id="rId9" imgW="2094909" imgH="3055547" progId="Prism6.Document">
                  <p:embed/>
                </p:oleObj>
              </mc:Choice>
              <mc:Fallback>
                <p:oleObj name="Prism 6" r:id="rId9" imgW="2094909" imgH="3055547" progId="Prism6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527828" y="1834014"/>
                        <a:ext cx="834021" cy="12162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CB87396B-E0FA-4871-B99F-921C232D76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1947854"/>
              </p:ext>
            </p:extLst>
          </p:nvPr>
        </p:nvGraphicFramePr>
        <p:xfrm>
          <a:off x="613168" y="3487480"/>
          <a:ext cx="2431911" cy="18540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6" r:id="rId11" imgW="3814557" imgH="2908964" progId="Prism6.Document">
                  <p:embed/>
                </p:oleObj>
              </mc:Choice>
              <mc:Fallback>
                <p:oleObj name="Prism 6" r:id="rId11" imgW="3814557" imgH="2908964" progId="Prism6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13168" y="3487480"/>
                        <a:ext cx="2431911" cy="18540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8B87F3BC-DB16-4642-B9BF-C86F01EFC3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3877259"/>
              </p:ext>
            </p:extLst>
          </p:nvPr>
        </p:nvGraphicFramePr>
        <p:xfrm>
          <a:off x="613552" y="1672025"/>
          <a:ext cx="2431911" cy="18540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6" r:id="rId13" imgW="3814557" imgH="2908964" progId="Prism6.Document">
                  <p:embed/>
                </p:oleObj>
              </mc:Choice>
              <mc:Fallback>
                <p:oleObj name="Prism 6" r:id="rId13" imgW="3814557" imgH="2908964" progId="Prism6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13552" y="1672025"/>
                        <a:ext cx="2431911" cy="18540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B0C82E80-8A16-458E-86EB-7430078280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0054278"/>
              </p:ext>
            </p:extLst>
          </p:nvPr>
        </p:nvGraphicFramePr>
        <p:xfrm>
          <a:off x="613552" y="5500262"/>
          <a:ext cx="2431911" cy="1860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6" r:id="rId15" imgW="3814557" imgH="2918328" progId="Prism6.Document">
                  <p:embed/>
                </p:oleObj>
              </mc:Choice>
              <mc:Fallback>
                <p:oleObj name="Prism 6" r:id="rId15" imgW="3814557" imgH="2918328" progId="Prism6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13552" y="5500262"/>
                        <a:ext cx="2431911" cy="1860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6D81D68C-FC4A-48C8-833C-1697476ECD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58746"/>
              </p:ext>
            </p:extLst>
          </p:nvPr>
        </p:nvGraphicFramePr>
        <p:xfrm>
          <a:off x="4185722" y="1638767"/>
          <a:ext cx="2431911" cy="1860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6" r:id="rId17" imgW="3814557" imgH="2918328" progId="Prism6.Document">
                  <p:embed/>
                </p:oleObj>
              </mc:Choice>
              <mc:Fallback>
                <p:oleObj name="Prism 6" r:id="rId17" imgW="3814557" imgH="2918328" progId="Prism6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185722" y="1638767"/>
                        <a:ext cx="2431911" cy="1860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FD212C28-F92E-4311-99A4-71DA81D9C1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7336322"/>
              </p:ext>
            </p:extLst>
          </p:nvPr>
        </p:nvGraphicFramePr>
        <p:xfrm>
          <a:off x="6503500" y="3691336"/>
          <a:ext cx="837180" cy="12162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6" r:id="rId19" imgW="2103913" imgH="3055547" progId="Prism6.Document">
                  <p:embed/>
                </p:oleObj>
              </mc:Choice>
              <mc:Fallback>
                <p:oleObj name="Prism 6" r:id="rId19" imgW="2103913" imgH="3055547" progId="Prism6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FE409E85-6708-5750-6205-0278B5EDD8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6503500" y="3691336"/>
                        <a:ext cx="837180" cy="12162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A8B6F059-86D5-4F76-A2AE-19C2D2D54F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51742"/>
              </p:ext>
            </p:extLst>
          </p:nvPr>
        </p:nvGraphicFramePr>
        <p:xfrm>
          <a:off x="6480203" y="5766960"/>
          <a:ext cx="818858" cy="12232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6" r:id="rId21" imgW="2058176" imgH="3073555" progId="Prism6.Document">
                  <p:embed/>
                </p:oleObj>
              </mc:Choice>
              <mc:Fallback>
                <p:oleObj name="Prism 6" r:id="rId21" imgW="2058176" imgH="3073555" progId="Prism6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6644DDE1-25FE-1C1D-A8DB-9C6EC3BF69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6480203" y="5766960"/>
                        <a:ext cx="818858" cy="12232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09F8A2B7-39B8-4A2B-9697-777CE68BDD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1341462"/>
              </p:ext>
            </p:extLst>
          </p:nvPr>
        </p:nvGraphicFramePr>
        <p:xfrm>
          <a:off x="4799203" y="7603192"/>
          <a:ext cx="876917" cy="1149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6" r:id="rId23" imgW="2204391" imgH="2890596" progId="Prism6.Document">
                  <p:embed/>
                </p:oleObj>
              </mc:Choice>
              <mc:Fallback>
                <p:oleObj name="Prism 6" r:id="rId23" imgW="2204391" imgH="2890596" progId="Prism6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2B796886-90F2-14A8-AC77-5ED07095A5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799203" y="7603192"/>
                        <a:ext cx="876917" cy="1149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6F11A42C-ED9D-410B-A10A-B62E3E057E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8447249"/>
              </p:ext>
            </p:extLst>
          </p:nvPr>
        </p:nvGraphicFramePr>
        <p:xfrm>
          <a:off x="2503926" y="7385595"/>
          <a:ext cx="2414707" cy="18540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ism 6" r:id="rId25" imgW="3787187" imgH="2908964" progId="Prism6.Document">
                  <p:embed/>
                </p:oleObj>
              </mc:Choice>
              <mc:Fallback>
                <p:oleObj name="Prism 6" r:id="rId25" imgW="3787187" imgH="2908964" progId="Prism6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79D2D8C7-0DCD-979B-0FAE-925B309135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503926" y="7385595"/>
                        <a:ext cx="2414707" cy="18540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CAEA34D5-FA6C-4D81-8925-0A128327A8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0370542"/>
              </p:ext>
            </p:extLst>
          </p:nvPr>
        </p:nvGraphicFramePr>
        <p:xfrm>
          <a:off x="4185722" y="3526066"/>
          <a:ext cx="2414707" cy="18540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Prism 6" r:id="rId27" imgW="3787187" imgH="2908964" progId="Prism6.Document">
                  <p:embed/>
                </p:oleObj>
              </mc:Choice>
              <mc:Fallback>
                <p:oleObj name="Prism 6" r:id="rId27" imgW="3787187" imgH="2908964" progId="Prism6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7317A90D-D1F4-7E7B-683F-353F5BB5D5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4185722" y="3526066"/>
                        <a:ext cx="2414707" cy="18540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A1FCE55F-B408-49F8-B7D3-7EDF8AABA1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3570522"/>
              </p:ext>
            </p:extLst>
          </p:nvPr>
        </p:nvGraphicFramePr>
        <p:xfrm>
          <a:off x="4200771" y="5557093"/>
          <a:ext cx="2414707" cy="18489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Prism 6" r:id="rId29" imgW="3787187" imgH="2899960" progId="Prism6.Document">
                  <p:embed/>
                </p:oleObj>
              </mc:Choice>
              <mc:Fallback>
                <p:oleObj name="Prism 6" r:id="rId29" imgW="3787187" imgH="2899960" progId="Prism6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9D6A9D98-1065-3599-BC8D-660A1749A8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4200771" y="5557093"/>
                        <a:ext cx="2414707" cy="18489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A1AF46A1-B3F1-46E4-B2BC-69C17BCAFDB9}"/>
              </a:ext>
            </a:extLst>
          </p:cNvPr>
          <p:cNvSpPr txBox="1"/>
          <p:nvPr/>
        </p:nvSpPr>
        <p:spPr>
          <a:xfrm>
            <a:off x="0" y="-10902"/>
            <a:ext cx="3520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rvival weights and cause of death.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5B6599B-EC6D-477E-8D54-C20A2957F129}"/>
              </a:ext>
            </a:extLst>
          </p:cNvPr>
          <p:cNvSpPr txBox="1"/>
          <p:nvPr/>
        </p:nvSpPr>
        <p:spPr>
          <a:xfrm>
            <a:off x="613552" y="1604543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F05C1CC-C98C-42CD-BC1F-F28ACD415998}"/>
              </a:ext>
            </a:extLst>
          </p:cNvPr>
          <p:cNvSpPr txBox="1"/>
          <p:nvPr/>
        </p:nvSpPr>
        <p:spPr>
          <a:xfrm>
            <a:off x="4230692" y="1604543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EB8866F-3BA5-4B57-A6CE-F6B704B835DA}"/>
              </a:ext>
            </a:extLst>
          </p:cNvPr>
          <p:cNvSpPr txBox="1"/>
          <p:nvPr/>
        </p:nvSpPr>
        <p:spPr>
          <a:xfrm>
            <a:off x="613552" y="3484066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0DE80BE-63D2-4C27-B35D-738709DAB131}"/>
              </a:ext>
            </a:extLst>
          </p:cNvPr>
          <p:cNvSpPr txBox="1"/>
          <p:nvPr/>
        </p:nvSpPr>
        <p:spPr>
          <a:xfrm>
            <a:off x="4230692" y="3484066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35FDD7C-7C70-43F0-BD0E-560C63A2D9F9}"/>
              </a:ext>
            </a:extLst>
          </p:cNvPr>
          <p:cNvSpPr txBox="1"/>
          <p:nvPr/>
        </p:nvSpPr>
        <p:spPr>
          <a:xfrm>
            <a:off x="613552" y="5502975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B730B1A-E6EB-41B3-B61F-7FD293F672CA}"/>
              </a:ext>
            </a:extLst>
          </p:cNvPr>
          <p:cNvSpPr txBox="1"/>
          <p:nvPr/>
        </p:nvSpPr>
        <p:spPr>
          <a:xfrm>
            <a:off x="4230692" y="5502975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4357D66-6C67-4957-9E30-D45DB2A2F132}"/>
              </a:ext>
            </a:extLst>
          </p:cNvPr>
          <p:cNvSpPr txBox="1"/>
          <p:nvPr/>
        </p:nvSpPr>
        <p:spPr>
          <a:xfrm>
            <a:off x="2532501" y="7339572"/>
            <a:ext cx="21530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66C4899-C142-1E1D-C2A7-49F44DD8E8D5}"/>
              </a:ext>
            </a:extLst>
          </p:cNvPr>
          <p:cNvSpPr txBox="1"/>
          <p:nvPr/>
        </p:nvSpPr>
        <p:spPr>
          <a:xfrm>
            <a:off x="6832600" y="0"/>
            <a:ext cx="939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ufi et al.</a:t>
            </a:r>
          </a:p>
        </p:txBody>
      </p:sp>
    </p:spTree>
    <p:extLst>
      <p:ext uri="{BB962C8B-B14F-4D97-AF65-F5344CB8AC3E}">
        <p14:creationId xmlns:p14="http://schemas.microsoft.com/office/powerpoint/2010/main" val="985104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8A4FFB0-D7E0-4A1F-A4EE-512A4A87BBFF}"/>
              </a:ext>
            </a:extLst>
          </p:cNvPr>
          <p:cNvSpPr txBox="1"/>
          <p:nvPr/>
        </p:nvSpPr>
        <p:spPr>
          <a:xfrm>
            <a:off x="0" y="0"/>
            <a:ext cx="6431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umor growth rate with combination therapy with gemcitabine, CXCR4i, and ICB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DBF7244-EBB9-4D1A-883F-C95BC0DED0D3}"/>
              </a:ext>
            </a:extLst>
          </p:cNvPr>
          <p:cNvGrpSpPr/>
          <p:nvPr/>
        </p:nvGrpSpPr>
        <p:grpSpPr>
          <a:xfrm>
            <a:off x="728951" y="1521511"/>
            <a:ext cx="6835273" cy="5042202"/>
            <a:chOff x="728951" y="1716381"/>
            <a:chExt cx="6835273" cy="5042202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47A890D7-CD24-46BF-9868-69FAFD6418F8}"/>
                </a:ext>
              </a:extLst>
            </p:cNvPr>
            <p:cNvGrpSpPr/>
            <p:nvPr/>
          </p:nvGrpSpPr>
          <p:grpSpPr>
            <a:xfrm>
              <a:off x="737193" y="1779712"/>
              <a:ext cx="6827031" cy="4978871"/>
              <a:chOff x="2869130" y="747623"/>
              <a:chExt cx="4314067" cy="3146197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84B5AF37-ACC0-493F-B26E-36819A82E1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-325" t="16078" b="29749"/>
              <a:stretch/>
            </p:blipFill>
            <p:spPr>
              <a:xfrm>
                <a:off x="2869130" y="747623"/>
                <a:ext cx="4308859" cy="3047137"/>
              </a:xfrm>
              <a:prstGeom prst="rect">
                <a:avLst/>
              </a:prstGeom>
            </p:spPr>
          </p:pic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7912F0F4-52CA-40DE-B18B-AE0DFFA43DF2}"/>
                  </a:ext>
                </a:extLst>
              </p:cNvPr>
              <p:cNvSpPr/>
              <p:nvPr/>
            </p:nvSpPr>
            <p:spPr>
              <a:xfrm>
                <a:off x="5539740" y="2186940"/>
                <a:ext cx="1643457" cy="170688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454607C-3539-4951-A6DF-3FA54B47CA7F}"/>
                </a:ext>
              </a:extLst>
            </p:cNvPr>
            <p:cNvSpPr/>
            <p:nvPr/>
          </p:nvSpPr>
          <p:spPr>
            <a:xfrm>
              <a:off x="737193" y="1779712"/>
              <a:ext cx="226978" cy="2140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C476118-E488-4689-A3EB-524D94D55AFF}"/>
                </a:ext>
              </a:extLst>
            </p:cNvPr>
            <p:cNvSpPr txBox="1"/>
            <p:nvPr/>
          </p:nvSpPr>
          <p:spPr>
            <a:xfrm>
              <a:off x="728951" y="1716721"/>
              <a:ext cx="215301" cy="2769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6217D73-20E5-4253-AA3F-494C51CE4A3B}"/>
                </a:ext>
              </a:extLst>
            </p:cNvPr>
            <p:cNvSpPr txBox="1"/>
            <p:nvPr/>
          </p:nvSpPr>
          <p:spPr>
            <a:xfrm>
              <a:off x="2716073" y="1716381"/>
              <a:ext cx="215301" cy="2769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B8AABCF-D5A6-422E-8622-5B528F3B7E43}"/>
                </a:ext>
              </a:extLst>
            </p:cNvPr>
            <p:cNvSpPr txBox="1"/>
            <p:nvPr/>
          </p:nvSpPr>
          <p:spPr>
            <a:xfrm>
              <a:off x="4561392" y="1716381"/>
              <a:ext cx="215301" cy="2769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A8F4990-BAD3-4729-8341-4B8D55D1EF80}"/>
                </a:ext>
              </a:extLst>
            </p:cNvPr>
            <p:cNvSpPr txBox="1"/>
            <p:nvPr/>
          </p:nvSpPr>
          <p:spPr>
            <a:xfrm>
              <a:off x="748870" y="3964667"/>
              <a:ext cx="215301" cy="2769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DC628BC-D104-44C4-9D64-0C37094AC6BD}"/>
                </a:ext>
              </a:extLst>
            </p:cNvPr>
            <p:cNvSpPr txBox="1"/>
            <p:nvPr/>
          </p:nvSpPr>
          <p:spPr>
            <a:xfrm>
              <a:off x="2716073" y="3964667"/>
              <a:ext cx="215301" cy="2769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422A90B1-D9AD-28EC-89F3-7BEA7ACFF34B}"/>
              </a:ext>
            </a:extLst>
          </p:cNvPr>
          <p:cNvSpPr txBox="1"/>
          <p:nvPr/>
        </p:nvSpPr>
        <p:spPr>
          <a:xfrm>
            <a:off x="6832600" y="0"/>
            <a:ext cx="939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ufi et al.</a:t>
            </a:r>
          </a:p>
        </p:txBody>
      </p:sp>
    </p:spTree>
    <p:extLst>
      <p:ext uri="{BB962C8B-B14F-4D97-AF65-F5344CB8AC3E}">
        <p14:creationId xmlns:p14="http://schemas.microsoft.com/office/powerpoint/2010/main" val="8215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76</TotalTime>
  <Words>141</Words>
  <Application>Microsoft Office PowerPoint</Application>
  <PresentationFormat>Custom</PresentationFormat>
  <Paragraphs>52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ji, Gulam A.</dc:creator>
  <cp:lastModifiedBy>Manji, Gulam A.</cp:lastModifiedBy>
  <cp:revision>56</cp:revision>
  <cp:lastPrinted>2022-09-20T14:52:29Z</cp:lastPrinted>
  <dcterms:created xsi:type="dcterms:W3CDTF">2022-08-23T15:27:12Z</dcterms:created>
  <dcterms:modified xsi:type="dcterms:W3CDTF">2023-12-24T17:24:03Z</dcterms:modified>
</cp:coreProperties>
</file>